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2FB72-D105-4F15-8D67-41E08443C8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7CF651-B98A-4BC6-AD74-A53D56E96A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AF5E0B-AFB8-4B03-92AB-6294969BB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86227-1C37-4D98-A475-CBDD0D2A8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D04D6-98FF-4B10-8F42-7B561FD24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7911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EA885-468C-4B36-BBB2-E51838620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007DBE-6E63-4687-98F1-228F03B7B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FB588A-29A8-4B57-A90B-EE3B3E4A0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2D8E84-05D1-4D53-B6CD-0231A8DD0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EF7D1-F64A-4EC0-A626-9869052A4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212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0B0F8C-1C7C-4420-AE30-7BACED1F8E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F77713-2668-41C8-9FB7-D5B1B4C70B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89BFE-9C7E-44DC-8A44-97FCA98A3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E4AA1-F4BD-487D-9854-57484E5BA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7713BD-4A61-4923-9F79-DE9098CC8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43280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B5C5F-5111-4280-B9BB-BFED7BE677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A10C4E-850C-462C-8DE3-C85F24FED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80F3D-6A97-48AA-8D15-7251F6C1D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809BE-C057-4AC7-B6D6-001753C5E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BEA32-28C9-453A-896B-1FF734F01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9205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FD9B2-C7D8-4297-8DEA-871A860F0A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9B9428-8E10-4337-AD41-157C9B3F8F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A2C90-D00A-408D-BA7B-73ED5B0CA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C1CE6-3BDE-4DE0-A748-DEA9228DD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C2DD04-5273-4AC8-8CEF-E09B85496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73544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2695D-612E-4B3C-8831-B6702CA46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DECF47-AA35-4729-A367-24E64F746D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5424AB-5D69-4E6A-8520-8722122169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B221DB-58ED-4B6D-849D-238A659B5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552C0A-12EF-44C2-8BDA-35F6EEA8D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52546B-6F8C-45AB-94C9-6DC0B6238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6643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B8F366-040B-4AFD-AE56-69D400EDF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7933AD-6C32-4BEB-9C5A-D0935CAEA2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F3B561-A393-4298-AAD6-61125D18F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007BCA-7F40-4294-9AF7-45F031AA24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4200A1-B156-43E4-BC35-819CF74EB1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8524CB-25E4-47A6-BD12-2BB3C3DE0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A0BB9B-1479-4B97-8D2F-90B4289BF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0EAA49-A613-4A5A-8981-2DC494FCF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9528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813FF2-FB47-4E93-91A7-24AF1D235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BB2D29-2472-4830-93A4-335D4FAC3D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3D78A1-4B4D-457F-857E-9F3A72999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E56677-30A2-453A-9DDC-5DBDA6B87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8206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2B77A8-0037-4A94-82F7-91AE068F7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ABB4F9-028C-439E-9FC9-508F32AEA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F717D3-08DB-4034-A268-284E5BBCE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807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645E1-7771-4224-9DF3-FBD228118C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308217-DAF0-4BCD-82C6-EF96C5CA5B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06F431-4632-490A-A475-65AC82001C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40533E-B755-441E-9FA2-E11F777B0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A5D96A-DD83-432E-98C7-BAAC1FC40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557618-5B19-41FA-A7B2-F479B931D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8838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707F1-62A2-44AF-8F76-F47C08A3A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9492AF-F933-4763-B608-944452B876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D463C4-B8FA-4545-9CA6-01DE856FAB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BDCAF3-AE13-4B08-9954-62C796A51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6B06FA-DA67-4D7E-8D7C-7AD6CA487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899407-11E0-4CD6-8A13-AF3731549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43194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D7FD93-5D57-4C11-AD06-D925DA2E7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C2CE0E-2974-4F42-A075-1D73032A3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FF4E1-60AB-4AB3-9ADA-4DC47B5EDB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6EEED-A04F-4732-9C77-94EA60CE290F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08111B-B259-4FB2-8BF8-C2F90A56D6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974129-5BE9-4658-BF75-E72D73EC0A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FF828-C2C3-403D-B703-9691DB080B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5534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03201" y="596198"/>
            <a:ext cx="10909299" cy="5355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one DM#2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5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ourier New" panose="02070309020205020404" pitchFamily="49" charset="0"/>
              </a:rPr>
              <a:t>’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nd sequence: (13 BP deletion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TAAACCTGACGTATTCCCAAGTCAACATACCAGTATACCAATAGGATGTGAATAATGTGTGTGT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-------------TTCCCAAGTCAACACTCCAGTATACCAATAGGATGTGAATAATGTGTGTG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3’ end sequence:(154BP deletion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CGCCACGTTCGCC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tgacgtattcccaagtcaacataccagtataccaataggatgtgaataatgtgtgtgttgagtttaaaaccatagcagttttgctctggcaagtaatgaaagcgttctcgcttcctgagtgtgagctccagcagactgcagagtggccagtc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CAGTTGTAGCCTGAC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CGCCACGTTCGCC----------------------------------------------------------------------------------------------------------------------------------------------------------CACAGTTGTAGCCTGA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lone </a:t>
            </a:r>
            <a:r>
              <a:rPr lang="en-US" altLang="en-US" sz="1200" b="1" dirty="0">
                <a:solidFill>
                  <a:srgbClr val="00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SM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#42: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5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ourier New" panose="02070309020205020404" pitchFamily="49" charset="0"/>
              </a:rPr>
              <a:t>’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nd sequence: (No deletion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TAAACCTGACGTATTCCCAAGTCAACATACCAGTATACCAATAGGATGTGAATAATGTGTGTG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TAAACCTGACGTATTCCCAAGTCAACATACCAGTATACCAATAGGATGTGAATAATGTGTGTG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3’ end sequence:(6BP addition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GCCACGTTCGCC------CCTGACGTATTCCCAAGTCAACATACCAGTATACCAATAGGATGTGAATAATGTGTG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GCCACGTTCGCCAATAAACCTGACGTATTCCCAAGTCAACATACCAGTATACCAATAGGATGTGAATAATGTGTG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one #36: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5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ourier New" panose="02070309020205020404" pitchFamily="49" charset="0"/>
              </a:rPr>
              <a:t>’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nd sequence: (112bp deletion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TAAAcctgacgtattcccaagtcaacataccagtataccaataggatgtgaataatgtgtgtgttgagtttaaaaccatagcagttttgctctggcaagtaatgaaagcgttctcgCTTCCTGAGTGTGAGC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GAACTGCCGTGTAAA---------------------------------------------------------------------------------------------------------------CTTCCTGAGTGTGAGC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3’ end sequence:(320bp deletion)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GCCCGCACCGATCGCCCTTCCCAACAGTTGCGCAGCCTGAATGGCGAATGGGACGCGCCCTGTAGCGGCGCATTAAGCGCGGCGGGTGTGGTGGTTACGCGCAGCGTGACCGCTACACTTGCCAGCGCCCTAGCGCCCGCTCCTTTCGCTTTCTTCCCTTCCTTTCTCGCCACGTTCGCC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tgacgtattcccaagtcaacataccagtataccaataggatgtgaataatgtgtgtgttgagtttaaaaccatagcagttttgctctggcaagtaatgaaagcgttctcgcttcctgagtgtgagctccagcagactgcagagtggccagtccACAGTTGTAGCCTG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GCCCGCACCGATCGC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-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AGTTGTAGCCTG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" name="TextBox 1"/>
          <p:cNvSpPr txBox="1"/>
          <p:nvPr/>
        </p:nvSpPr>
        <p:spPr>
          <a:xfrm>
            <a:off x="126999" y="6171168"/>
            <a:ext cx="119038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: Sequences of ligation sites in clones.  Addition or deletion on 5’ and 3’ end of the insert on DNA sequence</a:t>
            </a:r>
          </a:p>
        </p:txBody>
      </p:sp>
    </p:spTree>
    <p:extLst>
      <p:ext uri="{BB962C8B-B14F-4D97-AF65-F5344CB8AC3E}">
        <p14:creationId xmlns:p14="http://schemas.microsoft.com/office/powerpoint/2010/main" val="3534507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d off44</dc:creator>
  <cp:lastModifiedBy>hyd off44</cp:lastModifiedBy>
  <cp:revision>1</cp:revision>
  <dcterms:created xsi:type="dcterms:W3CDTF">2020-09-25T02:52:29Z</dcterms:created>
  <dcterms:modified xsi:type="dcterms:W3CDTF">2020-09-25T02:52:44Z</dcterms:modified>
</cp:coreProperties>
</file>